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144000" type="letter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35"/>
    <p:restoredTop sz="94807"/>
  </p:normalViewPr>
  <p:slideViewPr>
    <p:cSldViewPr snapToGrid="0" snapToObjects="1">
      <p:cViewPr varScale="1">
        <p:scale>
          <a:sx n="93" d="100"/>
          <a:sy n="93" d="100"/>
        </p:scale>
        <p:origin x="34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F39BB6-8E07-EC49-98F9-E398AF662058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EC5D5B-D510-C349-8F3F-67AA3A654E2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814849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44818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03550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63542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26102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83978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05637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47630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8764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4446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15416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03578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49477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o 19">
            <a:extLst>
              <a:ext uri="{FF2B5EF4-FFF2-40B4-BE49-F238E27FC236}">
                <a16:creationId xmlns:a16="http://schemas.microsoft.com/office/drawing/2014/main" id="{2F03E59D-16B2-EB4A-8A06-858ABA3E69FD}"/>
              </a:ext>
            </a:extLst>
          </p:cNvPr>
          <p:cNvGrpSpPr/>
          <p:nvPr/>
        </p:nvGrpSpPr>
        <p:grpSpPr>
          <a:xfrm>
            <a:off x="1073544" y="521387"/>
            <a:ext cx="5019032" cy="4040339"/>
            <a:chOff x="827678" y="324772"/>
            <a:chExt cx="5163219" cy="4163145"/>
          </a:xfrm>
        </p:grpSpPr>
        <p:pic>
          <p:nvPicPr>
            <p:cNvPr id="21" name="Imagen 20" descr="C:\Users\Aalevar\Downloads\DE_todos.tiff">
              <a:extLst>
                <a:ext uri="{FF2B5EF4-FFF2-40B4-BE49-F238E27FC236}">
                  <a16:creationId xmlns:a16="http://schemas.microsoft.com/office/drawing/2014/main" id="{1A5B33AA-4CC0-D741-8B7A-0F7E16A6F24E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27678" y="470075"/>
              <a:ext cx="5163219" cy="401784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0D3DC87C-378A-BE45-A7A4-6E590A9066D2}"/>
                </a:ext>
              </a:extLst>
            </p:cNvPr>
            <p:cNvSpPr txBox="1"/>
            <p:nvPr/>
          </p:nvSpPr>
          <p:spPr>
            <a:xfrm>
              <a:off x="1570567" y="325297"/>
              <a:ext cx="52931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8A43907C-D9EE-7340-AA21-538B68E691BD}"/>
                </a:ext>
              </a:extLst>
            </p:cNvPr>
            <p:cNvSpPr txBox="1"/>
            <p:nvPr/>
          </p:nvSpPr>
          <p:spPr>
            <a:xfrm>
              <a:off x="2791431" y="324773"/>
              <a:ext cx="81945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DPs ( 15 min)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6FF41DF7-9A7D-6046-8FDF-725DD2EFBE17}"/>
                </a:ext>
              </a:extLst>
            </p:cNvPr>
            <p:cNvSpPr txBox="1"/>
            <p:nvPr/>
          </p:nvSpPr>
          <p:spPr>
            <a:xfrm>
              <a:off x="4275233" y="324772"/>
              <a:ext cx="63831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DPs (4 h)</a:t>
              </a:r>
            </a:p>
          </p:txBody>
        </p:sp>
      </p:grpSp>
      <p:sp>
        <p:nvSpPr>
          <p:cNvPr id="2" name="Rectángulo 1">
            <a:extLst>
              <a:ext uri="{FF2B5EF4-FFF2-40B4-BE49-F238E27FC236}">
                <a16:creationId xmlns:a16="http://schemas.microsoft.com/office/drawing/2014/main" id="{7E6CFC24-6912-C24C-8C0B-5D51FF766A55}"/>
              </a:ext>
            </a:extLst>
          </p:cNvPr>
          <p:cNvSpPr/>
          <p:nvPr/>
        </p:nvSpPr>
        <p:spPr>
          <a:xfrm>
            <a:off x="772886" y="4639057"/>
            <a:ext cx="5519057" cy="15619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1.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Heatmap global comparison of all 151 DEGs identified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eatmaps of the differentially expressed genes (DEGs) associated to the CDPs-exposure in HeLa cell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showed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Columns represent the exposure time to CDPs and rows correspond to individual genes. The tree at left to heatmap shows the hierarchical clustering of samples. DEGs up- and down-regulated are indicated in colors as a rainbow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Gs up- and  down-regulated are showed in as rainbow.</a:t>
            </a:r>
            <a:endParaRPr lang="es-MX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0"/>
              </a:spcAft>
            </a:pPr>
            <a:endParaRPr lang="es-MX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305781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1</TotalTime>
  <Words>91</Words>
  <Application>Microsoft Macintosh PowerPoint</Application>
  <PresentationFormat>Carta (216 x 279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us Campos (UMSNH)</dc:creator>
  <cp:lastModifiedBy>Jesus Campos</cp:lastModifiedBy>
  <cp:revision>82</cp:revision>
  <cp:lastPrinted>2021-01-14T20:58:24Z</cp:lastPrinted>
  <dcterms:created xsi:type="dcterms:W3CDTF">2020-08-31T17:46:22Z</dcterms:created>
  <dcterms:modified xsi:type="dcterms:W3CDTF">2022-02-17T21:18:15Z</dcterms:modified>
</cp:coreProperties>
</file>